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86" r:id="rId2"/>
  </p:sldIdLst>
  <p:sldSz cx="12192000" cy="6858000"/>
  <p:notesSz cx="6858000" cy="9144000"/>
  <p:defaultTextStyle>
    <a:defPPr>
      <a:defRPr lang="en-QA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4694"/>
  </p:normalViewPr>
  <p:slideViewPr>
    <p:cSldViewPr snapToGrid="0" snapToObjects="1">
      <p:cViewPr varScale="1">
        <p:scale>
          <a:sx n="122" d="100"/>
          <a:sy n="122" d="100"/>
        </p:scale>
        <p:origin x="74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C1789A-FA1E-4D46-965E-14D518E6FFF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2CAFF0D-DCD8-7E4B-A9FD-011D013BF0F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Q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F874B7-7943-9F4C-84DC-8C81EB51AA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7720073-B42E-0E4D-B801-A9D64681BE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F866215-6542-0541-ACAD-652B867FDE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1017454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5F798E-A96A-164F-8D15-91CFDECF0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0A60EE7-FAAA-3944-AF7C-DCB3E22B1C4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59FD27E-C653-8A47-9C75-0B8F421DF4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B50918-AF00-4E43-9DE9-1BBB0E31E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AA4505-7654-BA40-8979-05B54FE480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10982344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90F870F-6F03-3F43-811A-F7E1B954EA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8BB4E83-2093-4847-971F-EBAC20EECF9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F45CD60-273E-4341-95D3-9D563BBB36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6D727F-D4DF-8647-96BB-FA8B525B6C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6C4B32-7A15-B846-A100-62C5F9C8AC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33250382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7E4DA7D-5020-9D42-AFAA-915B87E2A4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A547438-1BF6-B944-BE61-D15494BB903A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0AE615-FEF5-5D41-BB25-28742F9960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B9011A-509E-F34C-B9E0-8FA4A8251A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B57192-A021-FC46-A766-B5DE7347BF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12601273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2A834B-546A-004B-9E54-CBAD51D61F9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8E23B4-66F4-F241-95A8-449DCB71F51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816CB99-8F7E-F749-9EB8-F6F45E1D4A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53B90A-0A1B-8947-A27F-F9AD0CFD32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897D4C8-D80D-F845-9B5A-5E0CEB34AF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374134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9DFC6A-8713-8A4E-991F-3AC273B7427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902BAD2-B421-7F45-97B8-88A803BEC90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CB174DA-78CD-A249-A00F-0B646C8CBAD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3997F8E-3FBE-2245-8F57-1A517887B2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224BF0-B4C6-7A41-9AFC-7CB557A113D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9ADD4E-F485-8F41-B65A-59AA20A33F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251846989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C2BA28-1C76-5A48-9D88-BFA7DDEECF2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145EF70-3E3E-594E-A7B7-D7D99FAEB6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338A074-FAE9-9046-BCD2-0D18258B0C8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980BB47-4F3F-B745-BB8F-13E19772AD7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28B310-E0D3-6F4D-9A7C-F874BB02F1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16F8D0A-AF2E-894F-8543-99A3BBF9A3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58E3C38-0145-7F4F-966A-0BA92AC11D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E89C3CE-2AE4-2E4D-9375-7D661BDC0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25828000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100B4C-CEF3-584C-8434-D33FCC0507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9FD115B-8FF5-EE49-B562-B9AB508DB0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6772563-72F4-1F4F-9C62-F043D5A43F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D06577-DF25-DD44-B349-941CFCB6D4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359032661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F7C7682-8978-8746-AFE5-B2312CD2C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820630E0-913D-814F-B803-9CBFAD3741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70CD1CA-03DF-314E-99D4-938029D798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79901534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82869C-343C-CA46-A5A7-229D239903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1706E2A-2F6A-3D4D-B93A-6E242B27981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B5AE9BE-8406-1246-A789-E2B3E8032F2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8A73D1-49EE-F64E-9A6A-FA5FE082C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74FF70-83F5-3F40-A7FE-CB244D2446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7ECE14E-1CFE-0B45-B697-B1B3CDC107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28486831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FBC19E-926F-364C-8152-F79F234148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BAFE2F2-863A-5A4E-B09C-B8CF25702F2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Q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1C70E1B-C952-524F-9D57-D5D2F98BB2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D60CECE-0EB7-E347-89C2-3537E854BBB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7F61CF-A822-AC4D-A6B4-43B6D709FC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Q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4124A88-8503-F142-B98C-B4B7104BE8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2820787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B131B3-E4C4-CB42-8012-A17CB2DC392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Q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F64BCE5-7E9F-4E45-83F1-B9F356BD254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BFD9C6-87E7-9E40-B322-66025A52290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5134D6-7FAA-2E4C-9F0A-6E43DE4E0EF2}" type="datetimeFigureOut">
              <a:rPr lang="en-QA" smtClean="0"/>
              <a:t>5/2/23</a:t>
            </a:fld>
            <a:endParaRPr lang="en-Q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DFBE5EE-A9A8-FA4F-8FC6-32A9CBB3D4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Q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63224A-6A36-CF41-BE70-67DC9ACF229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2426C2-3FA1-E245-99A5-F6205888264A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13575219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QA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Group 9">
            <a:extLst>
              <a:ext uri="{FF2B5EF4-FFF2-40B4-BE49-F238E27FC236}">
                <a16:creationId xmlns:a16="http://schemas.microsoft.com/office/drawing/2014/main" id="{BE2059A2-6159-2443-AB67-81DACD0605BD}"/>
              </a:ext>
            </a:extLst>
          </p:cNvPr>
          <p:cNvGrpSpPr/>
          <p:nvPr/>
        </p:nvGrpSpPr>
        <p:grpSpPr>
          <a:xfrm>
            <a:off x="195580" y="-42648"/>
            <a:ext cx="11600815" cy="6689548"/>
            <a:chOff x="195580" y="-42648"/>
            <a:chExt cx="11600815" cy="668954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08EC12E9-8792-A440-9E6C-E15F9E570FF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95580" y="4259300"/>
              <a:ext cx="7950200" cy="2387600"/>
            </a:xfrm>
            <a:prstGeom prst="rect">
              <a:avLst/>
            </a:prstGeom>
          </p:spPr>
        </p:pic>
        <p:cxnSp>
          <p:nvCxnSpPr>
            <p:cNvPr id="5" name="Straight Arrow Connector 4">
              <a:extLst>
                <a:ext uri="{FF2B5EF4-FFF2-40B4-BE49-F238E27FC236}">
                  <a16:creationId xmlns:a16="http://schemas.microsoft.com/office/drawing/2014/main" id="{59244693-7058-2743-8B12-8FC9711829D1}"/>
                </a:ext>
              </a:extLst>
            </p:cNvPr>
            <p:cNvCxnSpPr>
              <a:cxnSpLocks/>
            </p:cNvCxnSpPr>
            <p:nvPr/>
          </p:nvCxnSpPr>
          <p:spPr>
            <a:xfrm>
              <a:off x="749872" y="3909287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Arrow Connector 5">
              <a:extLst>
                <a:ext uri="{FF2B5EF4-FFF2-40B4-BE49-F238E27FC236}">
                  <a16:creationId xmlns:a16="http://schemas.microsoft.com/office/drawing/2014/main" id="{2467955D-33AA-0A49-993A-CEE061B69975}"/>
                </a:ext>
              </a:extLst>
            </p:cNvPr>
            <p:cNvCxnSpPr>
              <a:cxnSpLocks/>
            </p:cNvCxnSpPr>
            <p:nvPr/>
          </p:nvCxnSpPr>
          <p:spPr>
            <a:xfrm>
              <a:off x="3645472" y="3909287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964512E6-57C1-0248-B4D2-F65412E9B8D5}"/>
                </a:ext>
              </a:extLst>
            </p:cNvPr>
            <p:cNvCxnSpPr>
              <a:cxnSpLocks/>
            </p:cNvCxnSpPr>
            <p:nvPr/>
          </p:nvCxnSpPr>
          <p:spPr>
            <a:xfrm>
              <a:off x="5074984" y="3909287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Arrow Connector 7">
              <a:extLst>
                <a:ext uri="{FF2B5EF4-FFF2-40B4-BE49-F238E27FC236}">
                  <a16:creationId xmlns:a16="http://schemas.microsoft.com/office/drawing/2014/main" id="{6CF58AA7-70EE-EC49-821B-94C4BA02FF9C}"/>
                </a:ext>
              </a:extLst>
            </p:cNvPr>
            <p:cNvCxnSpPr>
              <a:cxnSpLocks/>
            </p:cNvCxnSpPr>
            <p:nvPr/>
          </p:nvCxnSpPr>
          <p:spPr>
            <a:xfrm>
              <a:off x="6680963" y="3897370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Arrow Connector 8">
              <a:extLst>
                <a:ext uri="{FF2B5EF4-FFF2-40B4-BE49-F238E27FC236}">
                  <a16:creationId xmlns:a16="http://schemas.microsoft.com/office/drawing/2014/main" id="{338D942E-CD95-3A49-A6AA-6BD3FED10703}"/>
                </a:ext>
              </a:extLst>
            </p:cNvPr>
            <p:cNvCxnSpPr>
              <a:cxnSpLocks/>
            </p:cNvCxnSpPr>
            <p:nvPr/>
          </p:nvCxnSpPr>
          <p:spPr>
            <a:xfrm>
              <a:off x="2164144" y="3909287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15" name="Picture 14">
              <a:extLst>
                <a:ext uri="{FF2B5EF4-FFF2-40B4-BE49-F238E27FC236}">
                  <a16:creationId xmlns:a16="http://schemas.microsoft.com/office/drawing/2014/main" id="{9A57E964-2C8F-494E-9CEC-485CF465CB7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0660" y="863600"/>
              <a:ext cx="9258300" cy="2565400"/>
            </a:xfrm>
            <a:prstGeom prst="rect">
              <a:avLst/>
            </a:prstGeom>
          </p:spPr>
        </p:pic>
        <p:cxnSp>
          <p:nvCxnSpPr>
            <p:cNvPr id="16" name="Straight Arrow Connector 15">
              <a:extLst>
                <a:ext uri="{FF2B5EF4-FFF2-40B4-BE49-F238E27FC236}">
                  <a16:creationId xmlns:a16="http://schemas.microsoft.com/office/drawing/2014/main" id="{56069950-195B-2343-8AC0-FD499BB053EC}"/>
                </a:ext>
              </a:extLst>
            </p:cNvPr>
            <p:cNvCxnSpPr>
              <a:cxnSpLocks/>
            </p:cNvCxnSpPr>
            <p:nvPr/>
          </p:nvCxnSpPr>
          <p:spPr>
            <a:xfrm>
              <a:off x="826897" y="437194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7" name="Straight Arrow Connector 16">
              <a:extLst>
                <a:ext uri="{FF2B5EF4-FFF2-40B4-BE49-F238E27FC236}">
                  <a16:creationId xmlns:a16="http://schemas.microsoft.com/office/drawing/2014/main" id="{7019DEE6-5581-0741-8942-089B5C2FCEAB}"/>
                </a:ext>
              </a:extLst>
            </p:cNvPr>
            <p:cNvCxnSpPr>
              <a:cxnSpLocks/>
            </p:cNvCxnSpPr>
            <p:nvPr/>
          </p:nvCxnSpPr>
          <p:spPr>
            <a:xfrm>
              <a:off x="3795776" y="420758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4E78C455-27F3-9A4F-BE28-8792B36C10FE}"/>
                </a:ext>
              </a:extLst>
            </p:cNvPr>
            <p:cNvCxnSpPr>
              <a:cxnSpLocks/>
            </p:cNvCxnSpPr>
            <p:nvPr/>
          </p:nvCxnSpPr>
          <p:spPr>
            <a:xfrm>
              <a:off x="5225288" y="420758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A016970B-558D-3B42-94E9-EFFDF65A0D7A}"/>
                </a:ext>
              </a:extLst>
            </p:cNvPr>
            <p:cNvCxnSpPr>
              <a:cxnSpLocks/>
            </p:cNvCxnSpPr>
            <p:nvPr/>
          </p:nvCxnSpPr>
          <p:spPr>
            <a:xfrm>
              <a:off x="6642608" y="420758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822AE0A1-35DC-B24A-B951-3CF8FA29D295}"/>
                </a:ext>
              </a:extLst>
            </p:cNvPr>
            <p:cNvCxnSpPr>
              <a:cxnSpLocks/>
            </p:cNvCxnSpPr>
            <p:nvPr/>
          </p:nvCxnSpPr>
          <p:spPr>
            <a:xfrm>
              <a:off x="8169656" y="420758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EDC5526F-BF40-C24D-90A3-16C8596675C2}"/>
                </a:ext>
              </a:extLst>
            </p:cNvPr>
            <p:cNvCxnSpPr>
              <a:cxnSpLocks/>
            </p:cNvCxnSpPr>
            <p:nvPr/>
          </p:nvCxnSpPr>
          <p:spPr>
            <a:xfrm>
              <a:off x="2314448" y="420758"/>
              <a:ext cx="1289304" cy="0"/>
            </a:xfrm>
            <a:prstGeom prst="straightConnector1">
              <a:avLst/>
            </a:prstGeom>
            <a:ln w="381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TextBox 21">
              <a:extLst>
                <a:ext uri="{FF2B5EF4-FFF2-40B4-BE49-F238E27FC236}">
                  <a16:creationId xmlns:a16="http://schemas.microsoft.com/office/drawing/2014/main" id="{F376B4CB-5F3C-604E-84BC-AC07DB8F5620}"/>
                </a:ext>
              </a:extLst>
            </p:cNvPr>
            <p:cNvSpPr txBox="1"/>
            <p:nvPr/>
          </p:nvSpPr>
          <p:spPr>
            <a:xfrm>
              <a:off x="826897" y="165111"/>
              <a:ext cx="167030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Synthetic DNA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9F4187D3-C66F-7E40-8334-35690E1045EB}"/>
                </a:ext>
              </a:extLst>
            </p:cNvPr>
            <p:cNvSpPr txBox="1"/>
            <p:nvPr/>
          </p:nvSpPr>
          <p:spPr>
            <a:xfrm>
              <a:off x="2039176" y="-42648"/>
              <a:ext cx="213563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QA" sz="1400" dirty="0"/>
                <a:t>HEK293 expressing </a:t>
              </a:r>
            </a:p>
            <a:p>
              <a:pPr algn="ctr"/>
              <a:r>
                <a:rPr lang="en-QA" sz="1400" dirty="0"/>
                <a:t>M gene</a:t>
              </a:r>
            </a:p>
          </p:txBody>
        </p:sp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FA4F051E-6BD6-234F-87DF-52E1B18E2F7B}"/>
                </a:ext>
              </a:extLst>
            </p:cNvPr>
            <p:cNvSpPr txBox="1"/>
            <p:nvPr/>
          </p:nvSpPr>
          <p:spPr>
            <a:xfrm>
              <a:off x="4180903" y="147743"/>
              <a:ext cx="4339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I-1</a:t>
              </a:r>
            </a:p>
          </p:txBody>
        </p:sp>
        <p:sp>
          <p:nvSpPr>
            <p:cNvPr id="30" name="TextBox 29">
              <a:extLst>
                <a:ext uri="{FF2B5EF4-FFF2-40B4-BE49-F238E27FC236}">
                  <a16:creationId xmlns:a16="http://schemas.microsoft.com/office/drawing/2014/main" id="{929D904F-9A3D-864E-8892-615CEE76629A}"/>
                </a:ext>
              </a:extLst>
            </p:cNvPr>
            <p:cNvSpPr txBox="1"/>
            <p:nvPr/>
          </p:nvSpPr>
          <p:spPr>
            <a:xfrm>
              <a:off x="5705348" y="129417"/>
              <a:ext cx="4339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I-2</a:t>
              </a:r>
            </a:p>
          </p:txBody>
        </p:sp>
        <p:sp>
          <p:nvSpPr>
            <p:cNvPr id="31" name="TextBox 30">
              <a:extLst>
                <a:ext uri="{FF2B5EF4-FFF2-40B4-BE49-F238E27FC236}">
                  <a16:creationId xmlns:a16="http://schemas.microsoft.com/office/drawing/2014/main" id="{735B2567-F30A-A646-AF2B-FFF76669F2B5}"/>
                </a:ext>
              </a:extLst>
            </p:cNvPr>
            <p:cNvSpPr txBox="1"/>
            <p:nvPr/>
          </p:nvSpPr>
          <p:spPr>
            <a:xfrm>
              <a:off x="6986460" y="159179"/>
              <a:ext cx="4339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I-3</a:t>
              </a:r>
            </a:p>
          </p:txBody>
        </p:sp>
        <p:sp>
          <p:nvSpPr>
            <p:cNvPr id="32" name="TextBox 31">
              <a:extLst>
                <a:ext uri="{FF2B5EF4-FFF2-40B4-BE49-F238E27FC236}">
                  <a16:creationId xmlns:a16="http://schemas.microsoft.com/office/drawing/2014/main" id="{417C584B-6579-8840-9C28-A2477BE7424F}"/>
                </a:ext>
              </a:extLst>
            </p:cNvPr>
            <p:cNvSpPr txBox="1"/>
            <p:nvPr/>
          </p:nvSpPr>
          <p:spPr>
            <a:xfrm>
              <a:off x="8669209" y="140055"/>
              <a:ext cx="4339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I-4</a:t>
              </a:r>
            </a:p>
          </p:txBody>
        </p: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E9D3D3EC-0B58-5743-AF99-F5C7C51F44F9}"/>
                </a:ext>
              </a:extLst>
            </p:cNvPr>
            <p:cNvSpPr txBox="1"/>
            <p:nvPr/>
          </p:nvSpPr>
          <p:spPr>
            <a:xfrm>
              <a:off x="1394524" y="3574200"/>
              <a:ext cx="4339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I-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37779D81-7214-454F-891F-D5A25BD484C9}"/>
                </a:ext>
              </a:extLst>
            </p:cNvPr>
            <p:cNvSpPr txBox="1"/>
            <p:nvPr/>
          </p:nvSpPr>
          <p:spPr>
            <a:xfrm>
              <a:off x="2591816" y="3589753"/>
              <a:ext cx="4339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I-6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E5D1154C-7139-874F-9256-13CF7CFFAE93}"/>
                </a:ext>
              </a:extLst>
            </p:cNvPr>
            <p:cNvSpPr txBox="1"/>
            <p:nvPr/>
          </p:nvSpPr>
          <p:spPr>
            <a:xfrm>
              <a:off x="4200207" y="3604508"/>
              <a:ext cx="4339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I-7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EAD52A66-9A7A-B444-A642-276C59F00DB9}"/>
                </a:ext>
              </a:extLst>
            </p:cNvPr>
            <p:cNvSpPr txBox="1"/>
            <p:nvPr/>
          </p:nvSpPr>
          <p:spPr>
            <a:xfrm>
              <a:off x="5602351" y="3602507"/>
              <a:ext cx="4339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I-8</a:t>
              </a:r>
            </a:p>
          </p:txBody>
        </p:sp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7B11405-142F-C248-8A16-22F3F22F59CE}"/>
                </a:ext>
              </a:extLst>
            </p:cNvPr>
            <p:cNvSpPr txBox="1"/>
            <p:nvPr/>
          </p:nvSpPr>
          <p:spPr>
            <a:xfrm>
              <a:off x="6891655" y="3569939"/>
              <a:ext cx="43396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sz="1400" dirty="0"/>
                <a:t>I-9</a:t>
              </a:r>
            </a:p>
          </p:txBody>
        </p:sp>
        <p:sp>
          <p:nvSpPr>
            <p:cNvPr id="2" name="TextBox 1">
              <a:extLst>
                <a:ext uri="{FF2B5EF4-FFF2-40B4-BE49-F238E27FC236}">
                  <a16:creationId xmlns:a16="http://schemas.microsoft.com/office/drawing/2014/main" id="{37F1ABA9-C96C-0349-B0AA-CC6D41119CE3}"/>
                </a:ext>
              </a:extLst>
            </p:cNvPr>
            <p:cNvSpPr txBox="1"/>
            <p:nvPr/>
          </p:nvSpPr>
          <p:spPr>
            <a:xfrm>
              <a:off x="826897" y="589083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430FE513-1B92-6F42-B863-A80C16037F51}"/>
                </a:ext>
              </a:extLst>
            </p:cNvPr>
            <p:cNvSpPr txBox="1"/>
            <p:nvPr/>
          </p:nvSpPr>
          <p:spPr>
            <a:xfrm>
              <a:off x="2283270" y="583108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B04539CF-D65C-CC40-996D-0620C0595B62}"/>
                </a:ext>
              </a:extLst>
            </p:cNvPr>
            <p:cNvSpPr txBox="1"/>
            <p:nvPr/>
          </p:nvSpPr>
          <p:spPr>
            <a:xfrm>
              <a:off x="3739643" y="598475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DCAA974B-FFBF-DE47-B15B-D90518506DB5}"/>
                </a:ext>
              </a:extLst>
            </p:cNvPr>
            <p:cNvSpPr txBox="1"/>
            <p:nvPr/>
          </p:nvSpPr>
          <p:spPr>
            <a:xfrm>
              <a:off x="5246435" y="585509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CADA408-B50E-3D48-B9D9-15E9FD509F09}"/>
                </a:ext>
              </a:extLst>
            </p:cNvPr>
            <p:cNvSpPr txBox="1"/>
            <p:nvPr/>
          </p:nvSpPr>
          <p:spPr>
            <a:xfrm>
              <a:off x="6667024" y="584680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6B8AB7BA-E3B4-8B4F-8B79-1E3A5EEFD791}"/>
                </a:ext>
              </a:extLst>
            </p:cNvPr>
            <p:cNvSpPr txBox="1"/>
            <p:nvPr/>
          </p:nvSpPr>
          <p:spPr>
            <a:xfrm>
              <a:off x="8154082" y="598475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D2330F4E-1289-FC44-916B-74173CD215A6}"/>
                </a:ext>
              </a:extLst>
            </p:cNvPr>
            <p:cNvSpPr txBox="1"/>
            <p:nvPr/>
          </p:nvSpPr>
          <p:spPr>
            <a:xfrm>
              <a:off x="858266" y="3992932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7138E2AB-8C95-914E-96F7-58B31D1F5C78}"/>
                </a:ext>
              </a:extLst>
            </p:cNvPr>
            <p:cNvSpPr txBox="1"/>
            <p:nvPr/>
          </p:nvSpPr>
          <p:spPr>
            <a:xfrm>
              <a:off x="2291462" y="3985270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67B18172-FFAE-354B-9865-D88F84908DE4}"/>
                </a:ext>
              </a:extLst>
            </p:cNvPr>
            <p:cNvSpPr txBox="1"/>
            <p:nvPr/>
          </p:nvSpPr>
          <p:spPr>
            <a:xfrm>
              <a:off x="3687032" y="3969717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D18212C4-6DEA-F84F-8BC0-0F0EBAFB13CC}"/>
                </a:ext>
              </a:extLst>
            </p:cNvPr>
            <p:cNvSpPr txBox="1"/>
            <p:nvPr/>
          </p:nvSpPr>
          <p:spPr>
            <a:xfrm>
              <a:off x="5182822" y="3969717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D5A694E1-9231-E04B-B642-5381A7F66595}"/>
                </a:ext>
              </a:extLst>
            </p:cNvPr>
            <p:cNvSpPr txBox="1"/>
            <p:nvPr/>
          </p:nvSpPr>
          <p:spPr>
            <a:xfrm>
              <a:off x="6667024" y="3985270"/>
              <a:ext cx="15067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1        2       3</a:t>
              </a:r>
            </a:p>
          </p:txBody>
        </p:sp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4CDE1426-946F-1F42-B58B-D4E2D75BD10D}"/>
                </a:ext>
              </a:extLst>
            </p:cNvPr>
            <p:cNvSpPr txBox="1"/>
            <p:nvPr/>
          </p:nvSpPr>
          <p:spPr>
            <a:xfrm>
              <a:off x="8300465" y="4339049"/>
              <a:ext cx="3495930" cy="175432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M: Genruler 1 kb plus DNA marker</a:t>
              </a:r>
            </a:p>
            <a:p>
              <a:r>
                <a:rPr lang="en-QA" dirty="0"/>
                <a:t>1: M-2 fragment</a:t>
              </a:r>
            </a:p>
            <a:p>
              <a:r>
                <a:rPr lang="en-QA" dirty="0"/>
                <a:t>2: M-2 fragment + XbaI</a:t>
              </a:r>
            </a:p>
            <a:p>
              <a:r>
                <a:rPr lang="en-QA" dirty="0"/>
                <a:t>3: M-2 Fragment pre-inubated with dCas9-sgRNA-XbaI + XbaI</a:t>
              </a:r>
            </a:p>
            <a:p>
              <a:endParaRPr lang="en-QA" dirty="0"/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E0118192-CC54-E142-8F42-A570477901BF}"/>
                </a:ext>
              </a:extLst>
            </p:cNvPr>
            <p:cNvSpPr txBox="1"/>
            <p:nvPr/>
          </p:nvSpPr>
          <p:spPr>
            <a:xfrm>
              <a:off x="273368" y="584680"/>
              <a:ext cx="914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QA" dirty="0"/>
                <a:t>M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3205249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Macintosh PowerPoint</Application>
  <PresentationFormat>Widescreen</PresentationFormat>
  <Paragraphs>2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r. Mustapha Aouida</dc:creator>
  <cp:lastModifiedBy>Dr. Mustapha Aouida</cp:lastModifiedBy>
  <cp:revision>1</cp:revision>
  <dcterms:created xsi:type="dcterms:W3CDTF">2023-05-02T08:11:08Z</dcterms:created>
  <dcterms:modified xsi:type="dcterms:W3CDTF">2023-05-02T08:12:07Z</dcterms:modified>
</cp:coreProperties>
</file>